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81"/>
  </p:normalViewPr>
  <p:slideViewPr>
    <p:cSldViewPr snapToGrid="0" snapToObjects="1">
      <p:cViewPr varScale="1">
        <p:scale>
          <a:sx n="67" d="100"/>
          <a:sy n="67" d="100"/>
        </p:scale>
        <p:origin x="184" y="6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DDADF-FC45-0644-B5A4-3A82288C1ADE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4DA19-E8F3-A34A-8006-0DE0A297D9C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87849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DDADF-FC45-0644-B5A4-3A82288C1ADE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4DA19-E8F3-A34A-8006-0DE0A297D9C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612033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DDADF-FC45-0644-B5A4-3A82288C1ADE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4DA19-E8F3-A34A-8006-0DE0A297D9C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86060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DDADF-FC45-0644-B5A4-3A82288C1ADE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4DA19-E8F3-A34A-8006-0DE0A297D9C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012569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DDADF-FC45-0644-B5A4-3A82288C1ADE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4DA19-E8F3-A34A-8006-0DE0A297D9C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028062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DDADF-FC45-0644-B5A4-3A82288C1ADE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4DA19-E8F3-A34A-8006-0DE0A297D9C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058094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DDADF-FC45-0644-B5A4-3A82288C1ADE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4DA19-E8F3-A34A-8006-0DE0A297D9C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3957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DDADF-FC45-0644-B5A4-3A82288C1ADE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4DA19-E8F3-A34A-8006-0DE0A297D9C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37480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DDADF-FC45-0644-B5A4-3A82288C1ADE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4DA19-E8F3-A34A-8006-0DE0A297D9C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99638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DDADF-FC45-0644-B5A4-3A82288C1ADE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4DA19-E8F3-A34A-8006-0DE0A297D9C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20305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DDADF-FC45-0644-B5A4-3A82288C1ADE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4DA19-E8F3-A34A-8006-0DE0A297D9C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374194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DDDADF-FC45-0644-B5A4-3A82288C1ADE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94DA19-E8F3-A34A-8006-0DE0A297D9C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886174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8804" y="151847"/>
            <a:ext cx="3892436" cy="2907009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44207" y="332184"/>
            <a:ext cx="3925283" cy="2923433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8804" y="3255617"/>
            <a:ext cx="4417996" cy="3481841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70876" y="3446118"/>
            <a:ext cx="4007402" cy="32354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3890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048000" y="2690336"/>
            <a:ext cx="6096000" cy="1477328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Bef>
                <a:spcPts val="1200"/>
              </a:spcBef>
              <a:spcAft>
                <a:spcPts val="600"/>
              </a:spcAft>
            </a:pPr>
            <a:r>
              <a:rPr lang="en-US" altLang="zh-CN" b="1" kern="100" dirty="0">
                <a:solidFill>
                  <a:srgbClr val="FF0000"/>
                </a:solidFill>
                <a:latin typeface="Times New Roman" charset="0"/>
                <a:cs typeface="Times New Roman" charset="0"/>
              </a:rPr>
              <a:t>Fig S1. PD-L1 expression levels in FFA-treated primary hepatocytes. (A-B) </a:t>
            </a:r>
            <a:r>
              <a:rPr lang="en-US" altLang="zh-CN" kern="100" dirty="0">
                <a:solidFill>
                  <a:srgbClr val="FF0000"/>
                </a:solidFill>
                <a:latin typeface="Times New Roman" charset="0"/>
                <a:cs typeface="Times New Roman" charset="0"/>
              </a:rPr>
              <a:t>Rat primary hepatocytes were isolated and identified by using CK18 antibody. </a:t>
            </a:r>
            <a:r>
              <a:rPr lang="en-US" altLang="zh-CN" b="1" kern="100" dirty="0">
                <a:solidFill>
                  <a:srgbClr val="FF0000"/>
                </a:solidFill>
                <a:latin typeface="Times New Roman" charset="0"/>
                <a:cs typeface="Times New Roman" charset="0"/>
              </a:rPr>
              <a:t>(C-D)</a:t>
            </a:r>
            <a:r>
              <a:rPr lang="en-US" altLang="zh-CN" kern="100" dirty="0">
                <a:solidFill>
                  <a:srgbClr val="FF0000"/>
                </a:solidFill>
                <a:latin typeface="Times New Roman" charset="0"/>
                <a:cs typeface="Times New Roman" charset="0"/>
              </a:rPr>
              <a:t> PD-L1 expression levels were analyzed by </a:t>
            </a:r>
            <a:r>
              <a:rPr lang="en-US" altLang="zh-CN" kern="100" dirty="0" err="1">
                <a:solidFill>
                  <a:srgbClr val="FF0000"/>
                </a:solidFill>
                <a:latin typeface="Times New Roman" charset="0"/>
                <a:cs typeface="Times New Roman" charset="0"/>
              </a:rPr>
              <a:t>qRT</a:t>
            </a:r>
            <a:r>
              <a:rPr lang="en-US" altLang="zh-CN" kern="100" dirty="0">
                <a:solidFill>
                  <a:srgbClr val="FF0000"/>
                </a:solidFill>
                <a:latin typeface="Times New Roman" charset="0"/>
                <a:cs typeface="Times New Roman" charset="0"/>
              </a:rPr>
              <a:t>-PCR and western blot. </a:t>
            </a:r>
            <a:r>
              <a:rPr lang="en-US" altLang="zh-CN" kern="100">
                <a:solidFill>
                  <a:srgbClr val="FF0000"/>
                </a:solidFill>
                <a:latin typeface="Times New Roman" charset="0"/>
                <a:cs typeface="Times New Roman" charset="0"/>
              </a:rPr>
              <a:t>*P &lt; 0.05, **P &lt; 0.01.</a:t>
            </a:r>
            <a:endParaRPr lang="zh-CN" altLang="zh-CN" kern="100">
              <a:latin typeface="DengXian" charset="-122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37299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0</Words>
  <Application>Microsoft Macintosh PowerPoint</Application>
  <PresentationFormat>宽屏</PresentationFormat>
  <Paragraphs>1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DengXian</vt:lpstr>
      <vt:lpstr>DengXian Light</vt:lpstr>
      <vt:lpstr>Times New Roman</vt:lpstr>
      <vt:lpstr>Arial</vt:lpstr>
      <vt:lpstr>Office 主题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2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用户</dc:creator>
  <cp:lastModifiedBy>Microsoft Office 用户</cp:lastModifiedBy>
  <cp:revision>2</cp:revision>
  <dcterms:created xsi:type="dcterms:W3CDTF">2022-04-27T13:20:44Z</dcterms:created>
  <dcterms:modified xsi:type="dcterms:W3CDTF">2022-04-28T01:07:50Z</dcterms:modified>
</cp:coreProperties>
</file>